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80625" cy="7775575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68" autoAdjust="0"/>
    <p:restoredTop sz="94660"/>
  </p:normalViewPr>
  <p:slideViewPr>
    <p:cSldViewPr snapToGrid="0" showGuides="1">
      <p:cViewPr varScale="1">
        <p:scale>
          <a:sx n="94" d="100"/>
          <a:sy n="94" d="100"/>
        </p:scale>
        <p:origin x="5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7CCEE2-29ED-4479-B4BB-B7DA157D8EED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28725" y="1241425"/>
            <a:ext cx="4340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D82B87-9CAA-451C-8F26-C13F302227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346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D82B87-9CAA-451C-8F26-C13F3022273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1246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272531"/>
            <a:ext cx="8568531" cy="2707052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4083977"/>
            <a:ext cx="7560469" cy="1877297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850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813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413978"/>
            <a:ext cx="2173635" cy="65894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413978"/>
            <a:ext cx="6394896" cy="65894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074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173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1938496"/>
            <a:ext cx="8694539" cy="3234423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5203518"/>
            <a:ext cx="8694539" cy="1700906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064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2069887"/>
            <a:ext cx="4284266" cy="493353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2069887"/>
            <a:ext cx="4284266" cy="493353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796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13979"/>
            <a:ext cx="8694539" cy="150291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1906097"/>
            <a:ext cx="4264576" cy="934148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2840245"/>
            <a:ext cx="4264576" cy="41775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1906097"/>
            <a:ext cx="4285579" cy="934148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2840245"/>
            <a:ext cx="4285579" cy="41775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055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804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575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18372"/>
            <a:ext cx="3251264" cy="1814301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119540"/>
            <a:ext cx="5103316" cy="5525698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332673"/>
            <a:ext cx="3251264" cy="4321564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027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18372"/>
            <a:ext cx="3251264" cy="1814301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119540"/>
            <a:ext cx="5103316" cy="5525698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332673"/>
            <a:ext cx="3251264" cy="4321564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999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413979"/>
            <a:ext cx="8694539" cy="15029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2069887"/>
            <a:ext cx="8694539" cy="49335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7206808"/>
            <a:ext cx="2268141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B5312-9FF6-4C4D-AEBE-71B16A2AB527}" type="datetimeFigureOut">
              <a:rPr kumimoji="1" lang="ja-JP" altLang="en-US" smtClean="0"/>
              <a:t>2023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7206808"/>
            <a:ext cx="3402211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7206808"/>
            <a:ext cx="2268141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2EE8E-AFD6-4269-A0A4-876E2380F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5804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kumimoji="1"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kumimoji="1"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F1768EAE-AD5E-4E81-84A6-8125F0244C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6924010"/>
              </p:ext>
            </p:extLst>
          </p:nvPr>
        </p:nvGraphicFramePr>
        <p:xfrm>
          <a:off x="196850" y="476168"/>
          <a:ext cx="9588501" cy="653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3210">
                  <a:extLst>
                    <a:ext uri="{9D8B030D-6E8A-4147-A177-3AD203B41FA5}">
                      <a16:colId xmlns:a16="http://schemas.microsoft.com/office/drawing/2014/main" val="1716441470"/>
                    </a:ext>
                  </a:extLst>
                </a:gridCol>
                <a:gridCol w="350520">
                  <a:extLst>
                    <a:ext uri="{9D8B030D-6E8A-4147-A177-3AD203B41FA5}">
                      <a16:colId xmlns:a16="http://schemas.microsoft.com/office/drawing/2014/main" val="298818823"/>
                    </a:ext>
                  </a:extLst>
                </a:gridCol>
                <a:gridCol w="464820">
                  <a:extLst>
                    <a:ext uri="{9D8B030D-6E8A-4147-A177-3AD203B41FA5}">
                      <a16:colId xmlns:a16="http://schemas.microsoft.com/office/drawing/2014/main" val="149388777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07405739"/>
                    </a:ext>
                  </a:extLst>
                </a:gridCol>
                <a:gridCol w="1135380">
                  <a:extLst>
                    <a:ext uri="{9D8B030D-6E8A-4147-A177-3AD203B41FA5}">
                      <a16:colId xmlns:a16="http://schemas.microsoft.com/office/drawing/2014/main" val="1932674541"/>
                    </a:ext>
                  </a:extLst>
                </a:gridCol>
                <a:gridCol w="358140">
                  <a:extLst>
                    <a:ext uri="{9D8B030D-6E8A-4147-A177-3AD203B41FA5}">
                      <a16:colId xmlns:a16="http://schemas.microsoft.com/office/drawing/2014/main" val="813667248"/>
                    </a:ext>
                  </a:extLst>
                </a:gridCol>
                <a:gridCol w="316230">
                  <a:extLst>
                    <a:ext uri="{9D8B030D-6E8A-4147-A177-3AD203B41FA5}">
                      <a16:colId xmlns:a16="http://schemas.microsoft.com/office/drawing/2014/main" val="2168407468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373515178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696931166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658707537"/>
                    </a:ext>
                  </a:extLst>
                </a:gridCol>
                <a:gridCol w="1018540">
                  <a:extLst>
                    <a:ext uri="{9D8B030D-6E8A-4147-A177-3AD203B41FA5}">
                      <a16:colId xmlns:a16="http://schemas.microsoft.com/office/drawing/2014/main" val="1276601668"/>
                    </a:ext>
                  </a:extLst>
                </a:gridCol>
                <a:gridCol w="769620">
                  <a:extLst>
                    <a:ext uri="{9D8B030D-6E8A-4147-A177-3AD203B41FA5}">
                      <a16:colId xmlns:a16="http://schemas.microsoft.com/office/drawing/2014/main" val="2567958390"/>
                    </a:ext>
                  </a:extLst>
                </a:gridCol>
                <a:gridCol w="784860">
                  <a:extLst>
                    <a:ext uri="{9D8B030D-6E8A-4147-A177-3AD203B41FA5}">
                      <a16:colId xmlns:a16="http://schemas.microsoft.com/office/drawing/2014/main" val="1469869307"/>
                    </a:ext>
                  </a:extLst>
                </a:gridCol>
                <a:gridCol w="708660">
                  <a:extLst>
                    <a:ext uri="{9D8B030D-6E8A-4147-A177-3AD203B41FA5}">
                      <a16:colId xmlns:a16="http://schemas.microsoft.com/office/drawing/2014/main" val="3555260608"/>
                    </a:ext>
                  </a:extLst>
                </a:gridCol>
                <a:gridCol w="1113791">
                  <a:extLst>
                    <a:ext uri="{9D8B030D-6E8A-4147-A177-3AD203B41FA5}">
                      <a16:colId xmlns:a16="http://schemas.microsoft.com/office/drawing/2014/main" val="2339885677"/>
                    </a:ext>
                  </a:extLst>
                </a:gridCol>
              </a:tblGrid>
              <a:tr h="335911"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800" b="1" baseline="300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</a:t>
                      </a:r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oculation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d Inoculation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Inoculation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3624002"/>
                  </a:ext>
                </a:extLst>
              </a:tr>
              <a:tr h="455688">
                <a:tc gridSpan="2"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 strain/dose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 strain/dose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 strain/dose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al period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antibody-positive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nal Survival Number</a:t>
                      </a:r>
                      <a:endParaRPr kumimoji="1" lang="ja-JP" altLang="en-US" sz="800" b="1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th/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thanasia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3444962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R T88/3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8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856807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R T88/3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8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6397098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R T88/3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7847639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sbon60V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8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2400932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9; died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0; endpoint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5031993"/>
                  </a:ext>
                </a:extLst>
              </a:tr>
              <a:tr h="455688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3; endpoint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9; died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9; died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4702154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7; endpoint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7; died</a:t>
                      </a:r>
                    </a:p>
                  </a:txBody>
                  <a:tcPr anchor="ctr">
                    <a:lnB w="12700" cmpd="sng"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6889104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attenuated strain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9; endpoint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7; die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5139738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0674678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3649933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9; died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6; died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3218789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30; died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9955826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41; died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7363232"/>
                  </a:ext>
                </a:extLst>
              </a:tr>
              <a:tr h="319539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07 ΔMGF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S WT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7982667"/>
                  </a:ext>
                </a:extLst>
              </a:tr>
              <a:tr h="3359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nya05/TK-1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</a:t>
                      </a:r>
                      <a:r>
                        <a:rPr kumimoji="1" lang="en-US" altLang="ja-JP" sz="8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8; died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27; died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8811088"/>
                  </a:ext>
                </a:extLst>
              </a:tr>
              <a:tr h="455688"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* and 3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nya05/TK-1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10</a:t>
                      </a:r>
                      <a:r>
                        <a:rPr kumimoji="1" lang="en-US" altLang="ja-JP" sz="8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* and 1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11; endpoint*</a:t>
                      </a:r>
                    </a:p>
                    <a:p>
                      <a:pPr marL="0" marR="0" lvl="0" indent="0" algn="ctr" defTabSz="100803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19; endpoint*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16; endpoint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1, d13; endpoint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126858"/>
                  </a:ext>
                </a:extLst>
              </a:tr>
            </a:tbl>
          </a:graphicData>
        </a:graphic>
      </p:graphicFrame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540AFA74-AEAC-4616-9116-E80F9D35B301}"/>
              </a:ext>
            </a:extLst>
          </p:cNvPr>
          <p:cNvSpPr/>
          <p:nvPr/>
        </p:nvSpPr>
        <p:spPr>
          <a:xfrm>
            <a:off x="586738" y="7023265"/>
            <a:ext cx="892596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mber of antibody-positive,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number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pigs that tested positive for ASFV antibodies by ELISA (</a:t>
            </a:r>
            <a:r>
              <a:rPr lang="en-US" altLang="ja-JP" sz="900" kern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Dvet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r p11.5-indirect ELISA) during survival. Group 5,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habitation study. Sera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ere collected from pigs cohabiting with pigs or wild boars inoculated with ASFV Kenya05/Tk-1. The number of days was based on the day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f inoculation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ith ASFV. </a:t>
            </a:r>
            <a:r>
              <a:rPr lang="en-US" altLang="ja-JP" sz="9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ild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oar; </a:t>
            </a:r>
            <a:r>
              <a:rPr lang="en-US" altLang="ja-JP" sz="9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virus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oculated into pigs or boars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ohabitating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ith pigs from which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ra were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llected</a:t>
            </a:r>
            <a:r>
              <a:rPr lang="en-US" altLang="ja-JP" sz="9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lang="ja-JP" altLang="en-US" sz="9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C2625C9-8C7D-4218-88AB-3D7C1D9759AB}"/>
              </a:ext>
            </a:extLst>
          </p:cNvPr>
          <p:cNvSpPr txBox="1"/>
          <p:nvPr/>
        </p:nvSpPr>
        <p:spPr>
          <a:xfrm>
            <a:off x="420848" y="129063"/>
            <a:ext cx="3206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</a:t>
            </a:r>
            <a:r>
              <a:rPr kumimoji="1" lang="en-US" altLang="ja-JP" sz="9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tails of the ASFV inoculation protocol for pigs</a:t>
            </a:r>
            <a:endParaRPr kumimoji="1" lang="ja-JP" altLang="en-US" sz="9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1562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8</TotalTime>
  <Words>517</Words>
  <Application>Microsoft Office PowerPoint</Application>
  <PresentationFormat>ユーザー設定</PresentationFormat>
  <Paragraphs>19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邉　瑞季</dc:creator>
  <cp:lastModifiedBy>渡邉　瑞季</cp:lastModifiedBy>
  <cp:revision>59</cp:revision>
  <cp:lastPrinted>2022-07-04T01:08:28Z</cp:lastPrinted>
  <dcterms:created xsi:type="dcterms:W3CDTF">2022-06-09T01:29:07Z</dcterms:created>
  <dcterms:modified xsi:type="dcterms:W3CDTF">2023-05-29T06:38:35Z</dcterms:modified>
</cp:coreProperties>
</file>